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DC1B75E1-F224-4642-A01E-824EFD37F60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9DCC728-DBA3-4A46-ACB5-C861341F9DC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66F3EED1-7B7E-4D03-8EE6-0F22EE7D6F8D}"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9C2F895A-6281-41AF-B749-18DC02F8BEB2}"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2A493177-286E-43D7-ADC6-C869D5D2714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AA492BE-5EEB-4786-8161-3F2D94E0D8E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7D627A60-1A9B-4C6C-A553-ACDCA1808699}"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F64A823-C82A-4F94-BEF7-DBE4928C3DD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9E63648-0CCC-42B9-BD9A-E583F80991E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E95C584-AD65-47D9-8ACE-6E5E978A5D22}"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891D9C8-5FD3-4BBA-8C45-9FAEA761379B}"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B25DFA9F-F2F4-47DB-A3C2-3739A7279B0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9182160"/>
            <a:ext cx="1600200" cy="527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zh-CN"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9182160"/>
            <a:ext cx="2171520" cy="527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182160"/>
            <a:ext cx="1600200" cy="527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zh-CN"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BCAA092-3EDD-4022-B7E3-04CD2540F83C}" type="slidenum">
              <a:rPr b="0" lang="zh-CN"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image" Target="../media/image2.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1" name="Picture 2" descr="C:\Users\lml\Desktop\TS5-1.tif"/>
          <p:cNvPicPr/>
          <p:nvPr/>
        </p:nvPicPr>
        <p:blipFill>
          <a:blip r:embed="rId1"/>
          <a:stretch/>
        </p:blipFill>
        <p:spPr>
          <a:xfrm>
            <a:off x="260280" y="1281240"/>
            <a:ext cx="6326280" cy="6786360"/>
          </a:xfrm>
          <a:prstGeom prst="rect">
            <a:avLst/>
          </a:prstGeom>
          <a:ln w="12600">
            <a:solidFill>
              <a:srgbClr val="000000"/>
            </a:solidFill>
            <a:miter/>
          </a:ln>
        </p:spPr>
      </p:pic>
      <p:sp>
        <p:nvSpPr>
          <p:cNvPr id="42" name="TextBox 2"/>
          <p:cNvSpPr/>
          <p:nvPr/>
        </p:nvSpPr>
        <p:spPr>
          <a:xfrm>
            <a:off x="189000" y="415800"/>
            <a:ext cx="6370560" cy="70236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800" spc="-1" strike="noStrike">
                <a:solidFill>
                  <a:srgbClr val="000000"/>
                </a:solidFill>
                <a:latin typeface="Arial"/>
              </a:rPr>
              <a:t>Supplemental Figure 2.</a:t>
            </a:r>
            <a:r>
              <a:rPr b="1" lang="zh-CN" sz="800" spc="-1" strike="noStrike">
                <a:solidFill>
                  <a:srgbClr val="000000"/>
                </a:solidFill>
                <a:latin typeface="Arial"/>
              </a:rPr>
              <a:t> </a:t>
            </a:r>
            <a:r>
              <a:rPr b="1" lang="en-US" sz="800" spc="-1" strike="noStrike">
                <a:solidFill>
                  <a:srgbClr val="000000"/>
                </a:solidFill>
                <a:latin typeface="Arial"/>
              </a:rPr>
              <a:t>Survival curve of 18  prognostic-related genes (ATP5A1, TUBA1B, VDAC1, HSPA8, PCNA, VIM, ATP5B, ACTC1, HSPB1, IGF1R, ITCH, ANXA5, UBE2N, UBXN7, VDAC3, PRPF8, PHGDH, ABCC1).</a:t>
            </a:r>
            <a:r>
              <a:rPr b="0" lang="en-US" sz="800" spc="-1" strike="noStrike">
                <a:solidFill>
                  <a:srgbClr val="000000"/>
                </a:solidFill>
                <a:latin typeface="Arial"/>
              </a:rPr>
              <a:t> </a:t>
            </a:r>
            <a:endParaRPr b="0" lang="en-US" sz="800" spc="-1" strike="noStrike">
              <a:solidFill>
                <a:srgbClr val="000000"/>
              </a:solidFill>
              <a:latin typeface="Arial"/>
            </a:endParaRPr>
          </a:p>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Among them, 4 genes (ATP5A1, ACTC1, IGF1R and UBXN7) had significant difference in overall survival (OS) rate, 10 genes (TUBA1B, VDAC1, HSPA8, PCNA, VIM, ATP5B, HSPB1, VDAC3, PRPF8 and PHGDH) had significant difference in recurrence free survival (RFS)rate and 4 genes (ITCH, ANXA5, UBE2N and ABCC1) had significant difference both in OS and RFS.</a:t>
            </a:r>
            <a:endParaRPr b="0" lang="en-US" sz="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pic>
        <p:nvPicPr>
          <p:cNvPr id="43" name="Picture 2" descr="C:\Users\lml\Desktop\TS5-2.tif"/>
          <p:cNvPicPr/>
          <p:nvPr/>
        </p:nvPicPr>
        <p:blipFill>
          <a:blip r:embed="rId1"/>
          <a:stretch/>
        </p:blipFill>
        <p:spPr>
          <a:xfrm>
            <a:off x="260280" y="1208160"/>
            <a:ext cx="6299280" cy="7099200"/>
          </a:xfrm>
          <a:prstGeom prst="rect">
            <a:avLst/>
          </a:prstGeom>
          <a:ln w="12600">
            <a:solidFill>
              <a:srgbClr val="000000"/>
            </a:solidFill>
            <a:miter/>
          </a:ln>
        </p:spPr>
      </p:pic>
      <p:sp>
        <p:nvSpPr>
          <p:cNvPr id="44" name="TextBox 1"/>
          <p:cNvSpPr/>
          <p:nvPr/>
        </p:nvSpPr>
        <p:spPr>
          <a:xfrm>
            <a:off x="333360" y="128520"/>
            <a:ext cx="934920" cy="2613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100" spc="-1" strike="noStrike">
                <a:solidFill>
                  <a:srgbClr val="000000"/>
                </a:solidFill>
                <a:latin typeface="Arial"/>
                <a:ea typeface="Arial"/>
              </a:rPr>
              <a:t>Continued</a:t>
            </a:r>
            <a:endParaRPr b="0" lang="en-US" sz="11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6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8-11-06T09:16:45Z</dcterms:created>
  <dc:creator>sanshuilong</dc:creator>
  <dc:description/>
  <dc:language>en-US</dc:language>
  <cp:lastModifiedBy>MC SYSTEM</cp:lastModifiedBy>
  <dcterms:modified xsi:type="dcterms:W3CDTF">2019-07-31T11:01:08Z</dcterms:modified>
  <cp:revision>13</cp:revision>
  <dc:subject/>
  <dc:title>PowerPoint 演示文稿</dc:title>
</cp:coreProperties>
</file>